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B065E0-85B9-4A68-9CFB-7260C349155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45B5B4-D8CF-4F4D-874C-8F3B913D6C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4DCF2F-EBF5-4AC5-A203-A0EC8D0620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941B0A-A4E5-444D-9EB1-F42CFA0B29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11E022-6B83-460E-B234-1BC6772553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BD73F-D71D-4940-9D43-7B7896EA52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462F20-D643-4BD2-B317-36BA58560C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C79E5B-9C80-4CC0-94D3-D1C46AB4A7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3F2F34-8AF7-4276-8AD4-42A554FF65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C5E3C1-3560-4AAD-98C6-CC7D45871F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44EE42-D4C0-4F2A-B31E-CED4E6B585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E749E-B168-4C1A-9DE2-15BD1F66E2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0B70B7-0F76-4942-BC09-A5382706E46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4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5.png"/><Relationship Id="rId7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040" y="44280"/>
            <a:ext cx="22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6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091520" y="361800"/>
            <a:ext cx="3102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mparison of enrichment levels in GO-B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ross all lists and p &lt;0.01 versus p &lt;0.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1395360" y="857160"/>
          <a:ext cx="2136960" cy="59436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395360" y="857160"/>
                    <a:ext cx="2136960" cy="5943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"/>
          <p:cNvSpPr/>
          <p:nvPr/>
        </p:nvSpPr>
        <p:spPr>
          <a:xfrm>
            <a:off x="4874040" y="361800"/>
            <a:ext cx="3036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mparison of enrichment levels in GSE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cross all lists and p &lt;0.01 versus p &lt;0.0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6" name=""/>
          <p:cNvGraphicFramePr/>
          <p:nvPr/>
        </p:nvGraphicFramePr>
        <p:xfrm>
          <a:off x="4925880" y="838080"/>
          <a:ext cx="2745000" cy="60199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7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925880" y="838080"/>
                    <a:ext cx="2745000" cy="6019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5400" y="44280"/>
            <a:ext cx="230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6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827240" y="152280"/>
            <a:ext cx="408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mparison of Enrichment levels in GO-B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0" name=""/>
          <p:cNvGraphicFramePr/>
          <p:nvPr/>
        </p:nvGraphicFramePr>
        <p:xfrm>
          <a:off x="609480" y="533520"/>
          <a:ext cx="3141720" cy="14223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1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09480" y="533520"/>
                    <a:ext cx="3141720" cy="14223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2" name=""/>
          <p:cNvGraphicFramePr/>
          <p:nvPr/>
        </p:nvGraphicFramePr>
        <p:xfrm>
          <a:off x="4343400" y="3200400"/>
          <a:ext cx="4800600" cy="34290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3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343400" y="3200400"/>
                    <a:ext cx="4800600" cy="3429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4" name=""/>
          <p:cNvGraphicFramePr/>
          <p:nvPr/>
        </p:nvGraphicFramePr>
        <p:xfrm>
          <a:off x="9360" y="2060640"/>
          <a:ext cx="4876920" cy="47689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5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9360" y="2060640"/>
                    <a:ext cx="4876920" cy="4768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6" name=""/>
          <p:cNvSpPr/>
          <p:nvPr/>
        </p:nvSpPr>
        <p:spPr>
          <a:xfrm flipH="1" flipV="1">
            <a:off x="3322440" y="5915160"/>
            <a:ext cx="37764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H="1" flipV="1">
            <a:off x="3009600" y="5857920"/>
            <a:ext cx="37764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H="1" flipV="1">
            <a:off x="3047760" y="6019920"/>
            <a:ext cx="37764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H="1" flipV="1">
            <a:off x="8018280" y="4448160"/>
            <a:ext cx="37764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H="1" flipV="1">
            <a:off x="4343400" y="3257640"/>
            <a:ext cx="37800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H="1" flipV="1">
            <a:off x="3809880" y="3333240"/>
            <a:ext cx="378000" cy="180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 flipV="1">
            <a:off x="4257360" y="3409920"/>
            <a:ext cx="37764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flipH="1" flipV="1">
            <a:off x="7200720" y="5686560"/>
            <a:ext cx="37764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H="1" flipV="1">
            <a:off x="7772400" y="5791320"/>
            <a:ext cx="37800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flipH="1" flipV="1">
            <a:off x="4733640" y="4400640"/>
            <a:ext cx="37764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H="1" flipV="1">
            <a:off x="3733560" y="4495320"/>
            <a:ext cx="377640" cy="180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flipH="1" flipV="1">
            <a:off x="3276360" y="4572000"/>
            <a:ext cx="37764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flipH="1" flipV="1">
            <a:off x="2743200" y="4800600"/>
            <a:ext cx="37800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H="1" flipV="1">
            <a:off x="4114800" y="4876920"/>
            <a:ext cx="37800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H="1" flipV="1">
            <a:off x="3457440" y="6162840"/>
            <a:ext cx="37800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H="1" flipV="1">
            <a:off x="3457440" y="6772320"/>
            <a:ext cx="37800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flipH="1" flipV="1">
            <a:off x="3962160" y="6248520"/>
            <a:ext cx="37764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3" name=""/>
          <p:cNvGraphicFramePr/>
          <p:nvPr/>
        </p:nvGraphicFramePr>
        <p:xfrm>
          <a:off x="152280" y="762120"/>
          <a:ext cx="8229600" cy="57052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2280" y="762120"/>
                    <a:ext cx="8229600" cy="5705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5" name=""/>
          <p:cNvSpPr/>
          <p:nvPr/>
        </p:nvSpPr>
        <p:spPr>
          <a:xfrm>
            <a:off x="4826880" y="152280"/>
            <a:ext cx="399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mparison of Enrichment levels in GSE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H="1" flipV="1">
            <a:off x="3809880" y="2274480"/>
            <a:ext cx="378000" cy="180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flipH="1" flipV="1">
            <a:off x="4371840" y="2181240"/>
            <a:ext cx="37800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H="1" flipV="1">
            <a:off x="3447720" y="2849040"/>
            <a:ext cx="377640" cy="180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H="1" flipV="1">
            <a:off x="3438360" y="2933280"/>
            <a:ext cx="378000" cy="180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H="1" flipV="1">
            <a:off x="3801960" y="5764320"/>
            <a:ext cx="37800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H="1" flipV="1">
            <a:off x="4381200" y="6427800"/>
            <a:ext cx="37764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5040" y="44280"/>
            <a:ext cx="2296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6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"/>
          <p:cNvSpPr/>
          <p:nvPr/>
        </p:nvSpPr>
        <p:spPr>
          <a:xfrm>
            <a:off x="4827240" y="152280"/>
            <a:ext cx="401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mparison of Enrichment levels in KEG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4" name=""/>
          <p:cNvGraphicFramePr/>
          <p:nvPr/>
        </p:nvGraphicFramePr>
        <p:xfrm>
          <a:off x="152280" y="457200"/>
          <a:ext cx="6002280" cy="63738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85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2280" y="457200"/>
                    <a:ext cx="6002280" cy="6373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6" name=""/>
          <p:cNvSpPr/>
          <p:nvPr/>
        </p:nvSpPr>
        <p:spPr>
          <a:xfrm flipH="1" flipV="1">
            <a:off x="4092480" y="1879200"/>
            <a:ext cx="378000" cy="180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5400" y="44280"/>
            <a:ext cx="230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6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H="1" flipV="1">
            <a:off x="3049560" y="2763360"/>
            <a:ext cx="378000" cy="180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H="1" flipV="1">
            <a:off x="3124080" y="2952720"/>
            <a:ext cx="37800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flipH="1" flipV="1">
            <a:off x="3657600" y="4304880"/>
            <a:ext cx="378000" cy="180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flipH="1" flipV="1">
            <a:off x="4114800" y="6248520"/>
            <a:ext cx="37800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flipH="1" flipV="1">
            <a:off x="4705200" y="6734160"/>
            <a:ext cx="378000" cy="1440"/>
          </a:xfrm>
          <a:prstGeom prst="line">
            <a:avLst/>
          </a:prstGeom>
          <a:ln w="25560">
            <a:solidFill>
              <a:srgbClr val="ff0000"/>
            </a:solidFill>
            <a:miter/>
            <a:tailEnd len="lg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9T04:04:12Z</dcterms:created>
  <dc:creator>Kai Sonntag</dc:creator>
  <dc:description/>
  <dc:language>en-US</dc:language>
  <cp:lastModifiedBy>Kai Sonntag</cp:lastModifiedBy>
  <dcterms:modified xsi:type="dcterms:W3CDTF">2009-09-07T21:30:09Z</dcterms:modified>
  <cp:revision>25</cp:revision>
  <dc:subject/>
  <dc:title>PowerPoint Presentation</dc:title>
</cp:coreProperties>
</file>